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83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2.xlsx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192936895900454"/>
          <c:y val="0.11183993959518901"/>
          <c:w val="0.78536852386771827"/>
          <c:h val="0.7384146103107884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R$23</c:f>
              <c:strCache>
                <c:ptCount val="1"/>
                <c:pt idx="0">
                  <c:v>pecti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Lbls>
            <c:dLbl>
              <c:idx val="0"/>
              <c:layout>
                <c:manualLayout>
                  <c:x val="-2.3280154346093701E-17"/>
                  <c:y val="-2.3238925199709513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0"/>
                  <c:y val="-7.2621641249092234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0"/>
                  <c:y val="-6.1002178649237473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 val="0"/>
                  <c:y val="-0.11328976034858387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Sheet1!$S$24:$S$27</c:f>
                <c:numCache>
                  <c:formatCode>General</c:formatCode>
                  <c:ptCount val="4"/>
                  <c:pt idx="0">
                    <c:v>0.24634330078747119</c:v>
                  </c:pt>
                  <c:pt idx="1">
                    <c:v>0.58265305244613341</c:v>
                  </c:pt>
                  <c:pt idx="2">
                    <c:v>0.50128523201830977</c:v>
                  </c:pt>
                  <c:pt idx="3">
                    <c:v>0.83882928182340399</c:v>
                  </c:pt>
                </c:numCache>
              </c:numRef>
            </c:plus>
            <c:minus>
              <c:numRef>
                <c:f>Sheet1!$S$24:$S$27</c:f>
                <c:numCache>
                  <c:formatCode>General</c:formatCode>
                  <c:ptCount val="4"/>
                  <c:pt idx="0">
                    <c:v>0.24634330078747119</c:v>
                  </c:pt>
                  <c:pt idx="1">
                    <c:v>0.58265305244613341</c:v>
                  </c:pt>
                  <c:pt idx="2">
                    <c:v>0.50128523201830977</c:v>
                  </c:pt>
                  <c:pt idx="3">
                    <c:v>0.83882928182340399</c:v>
                  </c:pt>
                </c:numCache>
              </c:numRef>
            </c:minus>
          </c:errBars>
          <c:cat>
            <c:multiLvlStrRef>
              <c:f>Sheet1!$P$24:$Q$27</c:f>
              <c:multiLvlStrCache>
                <c:ptCount val="4"/>
                <c:lvl>
                  <c:pt idx="0">
                    <c:v>Ammonium</c:v>
                  </c:pt>
                  <c:pt idx="1">
                    <c:v>Nitrate</c:v>
                  </c:pt>
                  <c:pt idx="2">
                    <c:v>Ammonium</c:v>
                  </c:pt>
                  <c:pt idx="3">
                    <c:v>Nitrate</c:v>
                  </c:pt>
                </c:lvl>
                <c:lvl>
                  <c:pt idx="0">
                    <c:v>0.5 µM Mn</c:v>
                  </c:pt>
                  <c:pt idx="2">
                    <c:v>500 µM Mn</c:v>
                  </c:pt>
                </c:lvl>
              </c:multiLvlStrCache>
            </c:multiLvlStrRef>
          </c:cat>
          <c:val>
            <c:numRef>
              <c:f>Sheet1!$R$24:$R$27</c:f>
              <c:numCache>
                <c:formatCode>General</c:formatCode>
                <c:ptCount val="4"/>
                <c:pt idx="0">
                  <c:v>4.6436955510544697</c:v>
                </c:pt>
                <c:pt idx="1">
                  <c:v>4.394786336792226</c:v>
                </c:pt>
                <c:pt idx="2">
                  <c:v>3.7811230778849292</c:v>
                </c:pt>
                <c:pt idx="3">
                  <c:v>3.97461577583766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018560"/>
        <c:axId val="139093120"/>
      </c:barChart>
      <c:catAx>
        <c:axId val="150018560"/>
        <c:scaling>
          <c:orientation val="minMax"/>
        </c:scaling>
        <c:delete val="0"/>
        <c:axPos val="b"/>
        <c:majorTickMark val="out"/>
        <c:minorTickMark val="none"/>
        <c:tickLblPos val="nextTo"/>
        <c:crossAx val="139093120"/>
        <c:crosses val="autoZero"/>
        <c:auto val="1"/>
        <c:lblAlgn val="ctr"/>
        <c:lblOffset val="100"/>
        <c:noMultiLvlLbl val="0"/>
      </c:catAx>
      <c:valAx>
        <c:axId val="1390931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err="1"/>
                  <a:t>Uronic</a:t>
                </a:r>
                <a:r>
                  <a:rPr lang="en-US" dirty="0"/>
                  <a:t> acid in pectin (</a:t>
                </a:r>
                <a:r>
                  <a:rPr lang="en-US" dirty="0" smtClean="0"/>
                  <a:t>µg/mg </a:t>
                </a:r>
                <a:r>
                  <a:rPr lang="en-US" dirty="0"/>
                  <a:t>cell wall)</a:t>
                </a:r>
                <a:endParaRPr lang="zh-CN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0185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153551339507681"/>
          <c:y val="0.15670578512718861"/>
          <c:w val="0.77880793015834282"/>
          <c:h val="0.699909074430326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22</c:f>
              <c:strCache>
                <c:ptCount val="1"/>
                <c:pt idx="0">
                  <c:v>半纤维素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Lbls>
            <c:dLbl>
              <c:idx val="0"/>
              <c:layout>
                <c:manualLayout>
                  <c:x val="0"/>
                  <c:y val="-7.0329654101778633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2.635046113306983E-3"/>
                  <c:y val="-4.9816838322093202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0"/>
                  <c:y val="-3.2234424796648543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 val="0"/>
                  <c:y val="-2.3443218033926214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Sheet1!$T$23:$T$26</c:f>
                <c:numCache>
                  <c:formatCode>General</c:formatCode>
                  <c:ptCount val="4"/>
                  <c:pt idx="0">
                    <c:v>68.448975578550886</c:v>
                  </c:pt>
                  <c:pt idx="1">
                    <c:v>48.978852233512448</c:v>
                  </c:pt>
                  <c:pt idx="2">
                    <c:v>35.757083239413959</c:v>
                  </c:pt>
                  <c:pt idx="3">
                    <c:v>28.373402009303472</c:v>
                  </c:pt>
                </c:numCache>
              </c:numRef>
            </c:plus>
            <c:minus>
              <c:numRef>
                <c:f>Sheet1!$T$23:$T$26</c:f>
                <c:numCache>
                  <c:formatCode>General</c:formatCode>
                  <c:ptCount val="4"/>
                  <c:pt idx="0">
                    <c:v>68.448975578550886</c:v>
                  </c:pt>
                  <c:pt idx="1">
                    <c:v>48.978852233512448</c:v>
                  </c:pt>
                  <c:pt idx="2">
                    <c:v>35.757083239413959</c:v>
                  </c:pt>
                  <c:pt idx="3">
                    <c:v>28.373402009303472</c:v>
                  </c:pt>
                </c:numCache>
              </c:numRef>
            </c:minus>
          </c:errBars>
          <c:cat>
            <c:multiLvlStrRef>
              <c:f>Sheet1!$Q$23:$R$26</c:f>
              <c:multiLvlStrCache>
                <c:ptCount val="4"/>
                <c:lvl>
                  <c:pt idx="0">
                    <c:v>Ammonium</c:v>
                  </c:pt>
                  <c:pt idx="1">
                    <c:v>Nitrate</c:v>
                  </c:pt>
                  <c:pt idx="2">
                    <c:v>Ammonium</c:v>
                  </c:pt>
                  <c:pt idx="3">
                    <c:v>Nitrate</c:v>
                  </c:pt>
                </c:lvl>
                <c:lvl>
                  <c:pt idx="0">
                    <c:v>0.5 µM Mn</c:v>
                  </c:pt>
                  <c:pt idx="2">
                    <c:v>500 µM Mn</c:v>
                  </c:pt>
                </c:lvl>
              </c:multiLvlStrCache>
            </c:multiLvlStrRef>
          </c:cat>
          <c:val>
            <c:numRef>
              <c:f>Sheet1!$S$23:$S$26</c:f>
              <c:numCache>
                <c:formatCode>General</c:formatCode>
                <c:ptCount val="4"/>
                <c:pt idx="0">
                  <c:v>506.97237622820614</c:v>
                </c:pt>
                <c:pt idx="1">
                  <c:v>471.54403648160934</c:v>
                </c:pt>
                <c:pt idx="2">
                  <c:v>515.88845477638245</c:v>
                </c:pt>
                <c:pt idx="3">
                  <c:v>462.680365522571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019072"/>
        <c:axId val="139095424"/>
      </c:barChart>
      <c:catAx>
        <c:axId val="150019072"/>
        <c:scaling>
          <c:orientation val="minMax"/>
        </c:scaling>
        <c:delete val="0"/>
        <c:axPos val="b"/>
        <c:majorTickMark val="out"/>
        <c:minorTickMark val="none"/>
        <c:tickLblPos val="nextTo"/>
        <c:crossAx val="139095424"/>
        <c:crosses val="autoZero"/>
        <c:auto val="1"/>
        <c:lblAlgn val="ctr"/>
        <c:lblOffset val="100"/>
        <c:noMultiLvlLbl val="0"/>
      </c:catAx>
      <c:valAx>
        <c:axId val="13909542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err="1"/>
                  <a:t>Uronic</a:t>
                </a:r>
                <a:r>
                  <a:rPr lang="en-US" dirty="0"/>
                  <a:t> acid in hemicellulose (</a:t>
                </a:r>
                <a:r>
                  <a:rPr lang="en-US" dirty="0" smtClean="0"/>
                  <a:t>µg/mg </a:t>
                </a:r>
                <a:r>
                  <a:rPr lang="en-US" dirty="0"/>
                  <a:t>cell wall)</a:t>
                </a:r>
                <a:endParaRPr lang="zh-CN" dirty="0"/>
              </a:p>
            </c:rich>
          </c:tx>
          <c:layout>
            <c:manualLayout>
              <c:xMode val="edge"/>
              <c:yMode val="edge"/>
              <c:x val="3.9656556446580386E-2"/>
              <c:y val="9.7916021026903444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500190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D39A44-D863-413A-AC26-0E78F3995C7E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685CE3-85B5-4543-AEBC-22EA093B7D5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41862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-4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7077058"/>
              </p:ext>
            </p:extLst>
          </p:nvPr>
        </p:nvGraphicFramePr>
        <p:xfrm>
          <a:off x="281798" y="1196752"/>
          <a:ext cx="4320480" cy="388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74508461"/>
              </p:ext>
            </p:extLst>
          </p:nvPr>
        </p:nvGraphicFramePr>
        <p:xfrm>
          <a:off x="4442107" y="980728"/>
          <a:ext cx="4163246" cy="41044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矩形 3"/>
          <p:cNvSpPr/>
          <p:nvPr/>
        </p:nvSpPr>
        <p:spPr>
          <a:xfrm>
            <a:off x="641838" y="5345433"/>
            <a:ext cx="792088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GB" altLang="zh-CN" sz="1200" dirty="0" err="1">
                <a:solidFill>
                  <a:srgbClr val="000000"/>
                </a:solidFill>
                <a:latin typeface="Times New Roman"/>
              </a:rPr>
              <a:t>Uronic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 acid content of cell wall fractions extracted from roots of rice exposed to different N forms and </a:t>
            </a:r>
            <a:r>
              <a:rPr lang="en-GB" altLang="zh-CN" sz="1200" dirty="0" err="1">
                <a:solidFill>
                  <a:srgbClr val="000000"/>
                </a:solidFill>
                <a:latin typeface="Times New Roman"/>
              </a:rPr>
              <a:t>Mn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 concentrations under non-pH-buffered conditions. Rice seedlings (14 days old) were grown in a modified Kimura B nutrient solution (pH 4.5) containing 1 </a:t>
            </a:r>
            <a:r>
              <a:rPr lang="en-GB" altLang="zh-CN" sz="1200" dirty="0" err="1">
                <a:solidFill>
                  <a:srgbClr val="000000"/>
                </a:solidFill>
                <a:latin typeface="Times New Roman"/>
              </a:rPr>
              <a:t>mM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 ammonium or nitrate with 0.5 or 500 µM </a:t>
            </a:r>
            <a:r>
              <a:rPr lang="en-GB" altLang="zh-CN" sz="1200" dirty="0" err="1">
                <a:solidFill>
                  <a:srgbClr val="000000"/>
                </a:solidFill>
                <a:latin typeface="Times New Roman"/>
              </a:rPr>
              <a:t>Mn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 for 10 days. The roots were excised, and cell wall polysaccharides were fractionated into pectin (</a:t>
            </a:r>
            <a:r>
              <a:rPr lang="en-GB" altLang="zh-CN" sz="1200" b="1" dirty="0">
                <a:solidFill>
                  <a:srgbClr val="000000"/>
                </a:solidFill>
                <a:latin typeface="Times New Roman"/>
              </a:rPr>
              <a:t>A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) and hemicellulose (</a:t>
            </a:r>
            <a:r>
              <a:rPr lang="en-GB" altLang="zh-CN" sz="1200" b="1" dirty="0">
                <a:solidFill>
                  <a:srgbClr val="000000"/>
                </a:solidFill>
                <a:latin typeface="Times New Roman"/>
              </a:rPr>
              <a:t>B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) portions for </a:t>
            </a:r>
            <a:r>
              <a:rPr lang="en-GB" altLang="zh-CN" sz="1200" dirty="0" err="1">
                <a:solidFill>
                  <a:srgbClr val="000000"/>
                </a:solidFill>
                <a:latin typeface="Times New Roman"/>
              </a:rPr>
              <a:t>uronic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 acid content measurement. Data represent means ± SD (</a:t>
            </a:r>
            <a:r>
              <a:rPr lang="en-GB" altLang="zh-CN" sz="1200" i="1" dirty="0">
                <a:solidFill>
                  <a:srgbClr val="000000"/>
                </a:solidFill>
                <a:latin typeface="Times New Roman"/>
              </a:rPr>
              <a:t>n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 = 5). Different lowercase letters indicate a significant difference (</a:t>
            </a:r>
            <a:r>
              <a:rPr lang="en-GB" altLang="zh-CN" sz="1200" i="1" dirty="0">
                <a:solidFill>
                  <a:srgbClr val="000000"/>
                </a:solidFill>
                <a:latin typeface="Times New Roman"/>
              </a:rPr>
              <a:t>P </a:t>
            </a:r>
            <a:r>
              <a:rPr lang="en-GB" altLang="zh-CN" sz="1200" dirty="0">
                <a:solidFill>
                  <a:srgbClr val="000000"/>
                </a:solidFill>
                <a:latin typeface="Times New Roman"/>
              </a:rPr>
              <a:t>&lt; 0.05) based on Duncan’s test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11572" y="1112652"/>
            <a:ext cx="360040" cy="3139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44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499992" y="1149228"/>
            <a:ext cx="360040" cy="3139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4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44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8358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369</TotalTime>
  <Words>146</Words>
  <Application>Microsoft Office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nyong</dc:creator>
  <cp:lastModifiedBy>unknown</cp:lastModifiedBy>
  <cp:revision>118</cp:revision>
  <dcterms:created xsi:type="dcterms:W3CDTF">2018-09-16T03:58:39Z</dcterms:created>
  <dcterms:modified xsi:type="dcterms:W3CDTF">2019-04-04T12:12:05Z</dcterms:modified>
</cp:coreProperties>
</file>